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5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27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94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89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8704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247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086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235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579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503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718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377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324AD-53F0-48B1-8EB8-202E872081D2}" type="datetimeFigureOut">
              <a:rPr lang="en-US" smtClean="0"/>
              <a:t>2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1AED7B-7C24-4618-BA4D-978E3E082A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939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2001" y="685800"/>
            <a:ext cx="76962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Supplementary Figure </a:t>
            </a:r>
            <a:r>
              <a:rPr lang="en-US" sz="1200" b="1" dirty="0" smtClean="0"/>
              <a:t>4. </a:t>
            </a:r>
            <a:r>
              <a:rPr lang="en-US" sz="1200" dirty="0" smtClean="0"/>
              <a:t>Kaplan Meier plots showing clinical outcomes in a cohort of 88 neuroblastoma patients in association with the expression pattern of</a:t>
            </a:r>
            <a:r>
              <a:rPr lang="en-US" sz="1200" i="1" dirty="0" smtClean="0"/>
              <a:t> </a:t>
            </a:r>
            <a:r>
              <a:rPr lang="en-US" sz="1200" dirty="0" smtClean="0"/>
              <a:t>metastamiRs’ targets NOS3, ESR1, SELE, KRTAP1-1, MMP3, NF2, ELK-1, CXCR4, ADAMTS-1, ICAM-1, EGFR and ATK-1. All these targets showed induced expression levels in MSDACs (compared to parental SH-SY5Y) and manifold of metastatic tumors (compared with non-metastatic </a:t>
            </a:r>
            <a:r>
              <a:rPr lang="en-US" sz="1200" dirty="0" err="1" smtClean="0"/>
              <a:t>xenograft</a:t>
            </a:r>
            <a:r>
              <a:rPr lang="en-US" sz="1200" dirty="0" smtClean="0"/>
              <a:t>) as examined with immunoblotting.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762000" y="1676062"/>
            <a:ext cx="7696200" cy="4513072"/>
            <a:chOff x="762000" y="1676062"/>
            <a:chExt cx="7696200" cy="4513072"/>
          </a:xfrm>
        </p:grpSpPr>
        <p:pic>
          <p:nvPicPr>
            <p:cNvPr id="1045" name="Picture 21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8999" y="1981200"/>
              <a:ext cx="1828800" cy="134687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6" name="Picture 2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68598" y="1981200"/>
              <a:ext cx="1828800" cy="134687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8" name="Picture 2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27799" y="1981200"/>
              <a:ext cx="1828800" cy="134687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49" name="Picture 2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8999" y="3370059"/>
              <a:ext cx="1828800" cy="13618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0" name="Picture 2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68598" y="3370059"/>
              <a:ext cx="1828800" cy="13618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2" name="Picture 28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27799" y="3365742"/>
              <a:ext cx="1828800" cy="135026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3" name="Picture 2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8999" y="4772357"/>
              <a:ext cx="1828800" cy="134687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4" name="Picture 30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68598" y="4776341"/>
              <a:ext cx="1828800" cy="133890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5" name="Picture 31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8200" y="4763739"/>
              <a:ext cx="1828800" cy="136410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56" name="Picture 3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27799" y="4763739"/>
              <a:ext cx="1828800" cy="136410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/>
            <p:cNvPicPr>
              <a:picLocks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2" t="3370" r="16364" b="3237"/>
            <a:stretch/>
          </p:blipFill>
          <p:spPr bwMode="auto">
            <a:xfrm>
              <a:off x="4648200" y="3378595"/>
              <a:ext cx="1828800" cy="1353312"/>
            </a:xfrm>
            <a:prstGeom prst="rect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5524884" y="3357274"/>
              <a:ext cx="3802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VEGF</a:t>
              </a:r>
              <a:endParaRPr lang="en-US" sz="700" b="1" dirty="0"/>
            </a:p>
          </p:txBody>
        </p:sp>
        <p:pic>
          <p:nvPicPr>
            <p:cNvPr id="1028" name="Picture 4" descr="http://hgserver1.amc.nl/r2/graph/kaplanlast_quartile_nbadam88_VEGFA_210512_s_at-14123716228666.png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550" t="9560" r="10773" b="85803"/>
            <a:stretch/>
          </p:blipFill>
          <p:spPr bwMode="auto">
            <a:xfrm>
              <a:off x="880532" y="1676062"/>
              <a:ext cx="525128" cy="2743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" name="Picture 4" descr="http://hgserver1.amc.nl/r2/graph/kaplanlast_quartile_nbadam88_VEGFA_210512_s_at-14123716228666.png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550" t="14196" r="10773" b="81167"/>
            <a:stretch/>
          </p:blipFill>
          <p:spPr bwMode="auto">
            <a:xfrm>
              <a:off x="1676400" y="1700787"/>
              <a:ext cx="525126" cy="27432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Rectangle 3"/>
            <p:cNvSpPr/>
            <p:nvPr/>
          </p:nvSpPr>
          <p:spPr>
            <a:xfrm>
              <a:off x="762000" y="1693334"/>
              <a:ext cx="7696200" cy="449580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029" name="Picture 5"/>
            <p:cNvPicPr>
              <a:picLocks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3" t="4165" r="8307" b="3900"/>
            <a:stretch/>
          </p:blipFill>
          <p:spPr bwMode="auto">
            <a:xfrm>
              <a:off x="4656667" y="1983226"/>
              <a:ext cx="1828800" cy="13533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22" name="TextBox 21"/>
            <p:cNvSpPr txBox="1"/>
            <p:nvPr/>
          </p:nvSpPr>
          <p:spPr>
            <a:xfrm>
              <a:off x="5469467" y="1983226"/>
              <a:ext cx="4347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smtClean="0"/>
                <a:t>MMP9</a:t>
              </a:r>
              <a:endParaRPr lang="en-US" sz="7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43834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</TotalTime>
  <Words>84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Aravindan, Natarajan  (HSC)</cp:lastModifiedBy>
  <cp:revision>16</cp:revision>
  <dcterms:created xsi:type="dcterms:W3CDTF">2014-09-18T15:26:38Z</dcterms:created>
  <dcterms:modified xsi:type="dcterms:W3CDTF">2015-02-18T16:54:08Z</dcterms:modified>
</cp:coreProperties>
</file>